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23" d="100"/>
          <a:sy n="123" d="100"/>
        </p:scale>
        <p:origin x="-1248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81FD9-C8FF-49B9-A586-67D0515A8980}" type="datetimeFigureOut">
              <a:rPr lang="en-US" smtClean="0"/>
              <a:t>1/29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F92BCA-EF82-45BB-B230-79F170BBDC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67839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81FD9-C8FF-49B9-A586-67D0515A8980}" type="datetimeFigureOut">
              <a:rPr lang="en-US" smtClean="0"/>
              <a:t>1/29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F92BCA-EF82-45BB-B230-79F170BBDC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5659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81FD9-C8FF-49B9-A586-67D0515A8980}" type="datetimeFigureOut">
              <a:rPr lang="en-US" smtClean="0"/>
              <a:t>1/29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F92BCA-EF82-45BB-B230-79F170BBDC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29471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81FD9-C8FF-49B9-A586-67D0515A8980}" type="datetimeFigureOut">
              <a:rPr lang="en-US" smtClean="0"/>
              <a:t>1/29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F92BCA-EF82-45BB-B230-79F170BBDC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41666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81FD9-C8FF-49B9-A586-67D0515A8980}" type="datetimeFigureOut">
              <a:rPr lang="en-US" smtClean="0"/>
              <a:t>1/29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F92BCA-EF82-45BB-B230-79F170BBDC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18816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81FD9-C8FF-49B9-A586-67D0515A8980}" type="datetimeFigureOut">
              <a:rPr lang="en-US" smtClean="0"/>
              <a:t>1/29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F92BCA-EF82-45BB-B230-79F170BBDC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47325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81FD9-C8FF-49B9-A586-67D0515A8980}" type="datetimeFigureOut">
              <a:rPr lang="en-US" smtClean="0"/>
              <a:t>1/29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F92BCA-EF82-45BB-B230-79F170BBDC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08281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81FD9-C8FF-49B9-A586-67D0515A8980}" type="datetimeFigureOut">
              <a:rPr lang="en-US" smtClean="0"/>
              <a:t>1/29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F92BCA-EF82-45BB-B230-79F170BBDC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26768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81FD9-C8FF-49B9-A586-67D0515A8980}" type="datetimeFigureOut">
              <a:rPr lang="en-US" smtClean="0"/>
              <a:t>1/29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F92BCA-EF82-45BB-B230-79F170BBDC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49089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81FD9-C8FF-49B9-A586-67D0515A8980}" type="datetimeFigureOut">
              <a:rPr lang="en-US" smtClean="0"/>
              <a:t>1/29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F92BCA-EF82-45BB-B230-79F170BBDC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38092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81FD9-C8FF-49B9-A586-67D0515A8980}" type="datetimeFigureOut">
              <a:rPr lang="en-US" smtClean="0"/>
              <a:t>1/29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F92BCA-EF82-45BB-B230-79F170BBDC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00257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C81FD9-C8FF-49B9-A586-67D0515A8980}" type="datetimeFigureOut">
              <a:rPr lang="en-US" smtClean="0"/>
              <a:t>1/29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F92BCA-EF82-45BB-B230-79F170BBDC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48265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7096" y="-153138"/>
            <a:ext cx="8229600" cy="1143000"/>
          </a:xfrm>
        </p:spPr>
        <p:txBody>
          <a:bodyPr>
            <a:normAutofit/>
          </a:bodyPr>
          <a:lstStyle/>
          <a:p>
            <a:pPr algn="l"/>
            <a:r>
              <a:rPr lang="en-US" sz="1600" dirty="0" smtClean="0"/>
              <a:t>Supplemental Figure 2.  Validation of Dual Color </a:t>
            </a:r>
            <a:r>
              <a:rPr lang="en-US" sz="1600" i="1" dirty="0" smtClean="0"/>
              <a:t>In </a:t>
            </a:r>
            <a:r>
              <a:rPr lang="en-US" sz="1600" i="1" dirty="0"/>
              <a:t>S</a:t>
            </a:r>
            <a:r>
              <a:rPr lang="en-US" sz="1600" i="1" dirty="0" smtClean="0"/>
              <a:t>itu</a:t>
            </a:r>
            <a:r>
              <a:rPr lang="en-US" sz="1600" dirty="0" smtClean="0"/>
              <a:t> hybridization assay for NRG1 and HER3 in </a:t>
            </a:r>
            <a:r>
              <a:rPr lang="en-US" sz="1600" dirty="0"/>
              <a:t>I</a:t>
            </a:r>
            <a:r>
              <a:rPr lang="en-US" sz="1600" dirty="0" smtClean="0"/>
              <a:t>ndicated Cell Lines  </a:t>
            </a:r>
            <a:endParaRPr lang="en-US" sz="1600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6543" y="632575"/>
            <a:ext cx="7391181" cy="62345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27564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0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upplemental Figure 2.  Validation of Dual Color In Situ hybridization assay for NRG1 and HER3 in Indicated Cell Lines  </vt:lpstr>
    </vt:vector>
  </TitlesOfParts>
  <Company>Genentech, Inc.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Figure 2.  Validation of Dual Color In Situ hybridization assay for NRG1 and HER3 in Indicated Cell Lines  </dc:title>
  <dc:creator>Genentech</dc:creator>
  <cp:lastModifiedBy>Genentech</cp:lastModifiedBy>
  <cp:revision>1</cp:revision>
  <dcterms:created xsi:type="dcterms:W3CDTF">2013-01-30T00:45:21Z</dcterms:created>
  <dcterms:modified xsi:type="dcterms:W3CDTF">2013-01-30T00:45:55Z</dcterms:modified>
</cp:coreProperties>
</file>